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040313" cy="82804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436FE9F-6E71-410A-A5AB-09D67C427A92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77640" y="2571480"/>
            <a:ext cx="4282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52360" y="1936800"/>
            <a:ext cx="453384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52360" y="4790160"/>
            <a:ext cx="453384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2A161DC-B45D-45E2-B01D-D990AD8F2B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77640" y="2571480"/>
            <a:ext cx="4282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52360" y="1936800"/>
            <a:ext cx="22122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575440" y="1936800"/>
            <a:ext cx="22122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52360" y="4790160"/>
            <a:ext cx="22122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575440" y="4790160"/>
            <a:ext cx="22122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2BAAC4F-D7E0-4D67-9CD5-9521031F60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77640" y="2571480"/>
            <a:ext cx="4282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52360" y="1936800"/>
            <a:ext cx="14598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785600" y="1936800"/>
            <a:ext cx="14598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318840" y="1936800"/>
            <a:ext cx="14598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52360" y="4790160"/>
            <a:ext cx="14598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785600" y="4790160"/>
            <a:ext cx="14598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318840" y="4790160"/>
            <a:ext cx="14598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19B509C-EC0A-4279-8B63-091E3F4FC8FA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77640" y="2571480"/>
            <a:ext cx="4282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52360" y="1936800"/>
            <a:ext cx="4533840" cy="546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E5881D7-4368-4718-B607-709AF4135F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77640" y="2571480"/>
            <a:ext cx="4282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52360" y="1936800"/>
            <a:ext cx="4533840" cy="546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26AC8CF-7958-4192-AF49-3D81A489E0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77640" y="2571480"/>
            <a:ext cx="4282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52360" y="1936800"/>
            <a:ext cx="2212200" cy="546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575440" y="1936800"/>
            <a:ext cx="2212200" cy="546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1E194CE-3C7D-425B-9B95-8865DAA8237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77640" y="2571480"/>
            <a:ext cx="4282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24E189B-A1EE-4043-9C33-7C93022BBE3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77640" y="2571480"/>
            <a:ext cx="4282920" cy="8219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A019DD6-32AB-40EB-98A1-6E82B959719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77640" y="2571480"/>
            <a:ext cx="4282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52360" y="1936800"/>
            <a:ext cx="22122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575440" y="1936800"/>
            <a:ext cx="2212200" cy="546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52360" y="4790160"/>
            <a:ext cx="22122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97EE48A-49DE-4572-BD03-FBD42BB8BA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77640" y="2571480"/>
            <a:ext cx="4282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52360" y="1936800"/>
            <a:ext cx="2212200" cy="546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575440" y="1936800"/>
            <a:ext cx="22122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575440" y="4790160"/>
            <a:ext cx="22122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D320FB7-CBBE-4A85-826F-3755F659279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77640" y="2571480"/>
            <a:ext cx="4282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52360" y="1936800"/>
            <a:ext cx="22122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575440" y="1936800"/>
            <a:ext cx="221220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52360" y="4790160"/>
            <a:ext cx="4533840" cy="2605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CAFF8F5-ECCC-4FC4-B3FB-B5826C42BB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77640" y="2571480"/>
            <a:ext cx="4282920" cy="177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dt" idx="1"/>
          </p:nvPr>
        </p:nvSpPr>
        <p:spPr>
          <a:xfrm>
            <a:off x="252000" y="7675560"/>
            <a:ext cx="1174680" cy="43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  <a:defRPr b="0" lang="en-PH" sz="11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0" lang="en-PH" sz="1100" spc="-1" strike="noStrike">
                <a:solidFill>
                  <a:srgbClr val="000000"/>
                </a:solidFill>
                <a:latin typeface="Calibri"/>
                <a:ea typeface="Arial Unicode MS"/>
              </a:rPr>
              <a:t>7/28/1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"/>
          <p:cNvSpPr/>
          <p:nvPr/>
        </p:nvSpPr>
        <p:spPr>
          <a:xfrm>
            <a:off x="1722600" y="7675560"/>
            <a:ext cx="1595160" cy="44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sldNum" idx="2"/>
          </p:nvPr>
        </p:nvSpPr>
        <p:spPr>
          <a:xfrm>
            <a:off x="3611160" y="7675560"/>
            <a:ext cx="1174680" cy="43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  <a:defRPr b="0" lang="en-PH" sz="11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fld id="{2067E8F5-FA53-488C-901E-DBD77556E2A2}" type="slidenum">
              <a:rPr b="0" lang="en-PH" sz="11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body"/>
          </p:nvPr>
        </p:nvSpPr>
        <p:spPr>
          <a:xfrm>
            <a:off x="252360" y="1936800"/>
            <a:ext cx="4533840" cy="546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3479760"/>
            <a:ext cx="5040360" cy="63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PH" sz="1200" spc="-1" strike="noStrike">
                <a:solidFill>
                  <a:srgbClr val="000000"/>
                </a:solidFill>
                <a:latin typeface="Calibri"/>
                <a:ea typeface="Calibri"/>
              </a:rPr>
              <a:t>Figure S3: Relation between patients outcome and  radiosensitivity of GSC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PH" sz="1200" spc="-1" strike="noStrike">
                <a:solidFill>
                  <a:srgbClr val="000000"/>
                </a:solidFill>
                <a:latin typeface="Calibri"/>
                <a:ea typeface="Calibri"/>
              </a:rPr>
              <a:t>GSCs from group 1 and group 2 are described in the results section ; PFS, Progression-free survival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71280" y="71280"/>
            <a:ext cx="2027520" cy="3132360"/>
          </a:xfrm>
          <a:prstGeom prst="rect">
            <a:avLst/>
          </a:prstGeom>
          <a:ln w="0">
            <a:noFill/>
          </a:ln>
        </p:spPr>
      </p:pic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